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4" d="100"/>
          <a:sy n="124" d="100"/>
        </p:scale>
        <p:origin x="12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4849B-F2AD-4690-B8CC-78CE42BB5C6D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14072-1752-4EF1-A7D7-1EFFFFBC16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1081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4849B-F2AD-4690-B8CC-78CE42BB5C6D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14072-1752-4EF1-A7D7-1EFFFFBC16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9361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4849B-F2AD-4690-B8CC-78CE42BB5C6D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14072-1752-4EF1-A7D7-1EFFFFBC16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5981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4849B-F2AD-4690-B8CC-78CE42BB5C6D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14072-1752-4EF1-A7D7-1EFFFFBC16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32356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4849B-F2AD-4690-B8CC-78CE42BB5C6D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14072-1752-4EF1-A7D7-1EFFFFBC16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36552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4849B-F2AD-4690-B8CC-78CE42BB5C6D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14072-1752-4EF1-A7D7-1EFFFFBC16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37446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4849B-F2AD-4690-B8CC-78CE42BB5C6D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14072-1752-4EF1-A7D7-1EFFFFBC16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602030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4849B-F2AD-4690-B8CC-78CE42BB5C6D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14072-1752-4EF1-A7D7-1EFFFFBC16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0219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4849B-F2AD-4690-B8CC-78CE42BB5C6D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14072-1752-4EF1-A7D7-1EFFFFBC16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22692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4849B-F2AD-4690-B8CC-78CE42BB5C6D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14072-1752-4EF1-A7D7-1EFFFFBC16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8025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4849B-F2AD-4690-B8CC-78CE42BB5C6D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14072-1752-4EF1-A7D7-1EFFFFBC16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82172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E4849B-F2AD-4690-B8CC-78CE42BB5C6D}" type="datetimeFigureOut">
              <a:rPr lang="de-DE" smtClean="0"/>
              <a:t>21.10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914072-1752-4EF1-A7D7-1EFFFFBC166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7276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4" Type="http://schemas.openxmlformats.org/officeDocument/2006/relationships/image" Target="../media/image8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7" Type="http://schemas.openxmlformats.org/officeDocument/2006/relationships/image" Target="../media/image15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tiff"/><Relationship Id="rId5" Type="http://schemas.openxmlformats.org/officeDocument/2006/relationships/image" Target="../media/image13.tiff"/><Relationship Id="rId4" Type="http://schemas.openxmlformats.org/officeDocument/2006/relationships/image" Target="../media/image12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7" Type="http://schemas.openxmlformats.org/officeDocument/2006/relationships/image" Target="../media/image19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tiff"/><Relationship Id="rId5" Type="http://schemas.openxmlformats.org/officeDocument/2006/relationships/image" Target="../media/image17.tiff"/><Relationship Id="rId4" Type="http://schemas.openxmlformats.org/officeDocument/2006/relationships/image" Target="../media/image16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77" t="29638" r="19278" b="66484"/>
          <a:stretch/>
        </p:blipFill>
        <p:spPr>
          <a:xfrm>
            <a:off x="2963463" y="2288509"/>
            <a:ext cx="2160000" cy="12536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feld 4"/>
          <p:cNvSpPr txBox="1"/>
          <p:nvPr/>
        </p:nvSpPr>
        <p:spPr>
          <a:xfrm>
            <a:off x="5071143" y="1772920"/>
            <a:ext cx="69442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 µM BV6 [1 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5071630" y="1941967"/>
            <a:ext cx="93807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0 µM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VAD-fmk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[1 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5077142" y="2119975"/>
            <a:ext cx="5966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D95L [3 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Gerade Verbindung mit Pfeil 7"/>
          <p:cNvCxnSpPr/>
          <p:nvPr/>
        </p:nvCxnSpPr>
        <p:spPr>
          <a:xfrm flipH="1">
            <a:off x="5150943" y="2472293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feld 8"/>
          <p:cNvSpPr txBox="1"/>
          <p:nvPr/>
        </p:nvSpPr>
        <p:spPr>
          <a:xfrm>
            <a:off x="5224618" y="2372546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2758333" y="242049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2553007" y="2095905"/>
            <a:ext cx="4491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 [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Gerade Verbindung mit Pfeil 11"/>
          <p:cNvCxnSpPr/>
          <p:nvPr/>
        </p:nvCxnSpPr>
        <p:spPr>
          <a:xfrm flipH="1">
            <a:off x="5150943" y="2623658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feld 12"/>
          <p:cNvSpPr txBox="1"/>
          <p:nvPr/>
        </p:nvSpPr>
        <p:spPr>
          <a:xfrm>
            <a:off x="5224618" y="2531191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2758333" y="258468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Gerade Verbindung mit Pfeil 14"/>
          <p:cNvCxnSpPr/>
          <p:nvPr/>
        </p:nvCxnSpPr>
        <p:spPr>
          <a:xfrm flipH="1">
            <a:off x="5150943" y="2778725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feld 15"/>
          <p:cNvSpPr txBox="1"/>
          <p:nvPr/>
        </p:nvSpPr>
        <p:spPr>
          <a:xfrm>
            <a:off x="5224618" y="2689123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2758333" y="273614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Gerade Verbindung mit Pfeil 17"/>
          <p:cNvCxnSpPr/>
          <p:nvPr/>
        </p:nvCxnSpPr>
        <p:spPr>
          <a:xfrm flipH="1">
            <a:off x="5150943" y="2927337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feld 18"/>
          <p:cNvSpPr txBox="1"/>
          <p:nvPr/>
        </p:nvSpPr>
        <p:spPr>
          <a:xfrm>
            <a:off x="5224618" y="2834452"/>
            <a:ext cx="3866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2758333" y="287178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Gerade Verbindung mit Pfeil 20"/>
          <p:cNvCxnSpPr/>
          <p:nvPr/>
        </p:nvCxnSpPr>
        <p:spPr>
          <a:xfrm flipH="1">
            <a:off x="5150943" y="3112112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feld 21"/>
          <p:cNvSpPr txBox="1"/>
          <p:nvPr/>
        </p:nvSpPr>
        <p:spPr>
          <a:xfrm>
            <a:off x="5224618" y="3017213"/>
            <a:ext cx="3946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ADD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2758333" y="304821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Gerade Verbindung mit Pfeil 23"/>
          <p:cNvCxnSpPr/>
          <p:nvPr/>
        </p:nvCxnSpPr>
        <p:spPr>
          <a:xfrm flipH="1">
            <a:off x="5150943" y="3232880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feld 24"/>
          <p:cNvSpPr txBox="1"/>
          <p:nvPr/>
        </p:nvSpPr>
        <p:spPr>
          <a:xfrm>
            <a:off x="5224618" y="3138063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Gerade Verbindung mit Pfeil 25"/>
          <p:cNvCxnSpPr/>
          <p:nvPr/>
        </p:nvCxnSpPr>
        <p:spPr>
          <a:xfrm flipH="1">
            <a:off x="5150943" y="2327674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feld 26"/>
          <p:cNvSpPr txBox="1"/>
          <p:nvPr/>
        </p:nvSpPr>
        <p:spPr>
          <a:xfrm>
            <a:off x="5224618" y="2224026"/>
            <a:ext cx="4507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2758333" y="225883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9" name="Tabelle 2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8814592"/>
              </p:ext>
            </p:extLst>
          </p:nvPr>
        </p:nvGraphicFramePr>
        <p:xfrm>
          <a:off x="2963409" y="1603873"/>
          <a:ext cx="2160004" cy="683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4286">
                  <a:extLst>
                    <a:ext uri="{9D8B030D-6E8A-4147-A177-3AD203B41FA5}">
                      <a16:colId xmlns:a16="http://schemas.microsoft.com/office/drawing/2014/main" val="2832158475"/>
                    </a:ext>
                  </a:extLst>
                </a:gridCol>
                <a:gridCol w="154286">
                  <a:extLst>
                    <a:ext uri="{9D8B030D-6E8A-4147-A177-3AD203B41FA5}">
                      <a16:colId xmlns:a16="http://schemas.microsoft.com/office/drawing/2014/main" val="1848485906"/>
                    </a:ext>
                  </a:extLst>
                </a:gridCol>
                <a:gridCol w="154286">
                  <a:extLst>
                    <a:ext uri="{9D8B030D-6E8A-4147-A177-3AD203B41FA5}">
                      <a16:colId xmlns:a16="http://schemas.microsoft.com/office/drawing/2014/main" val="2677818888"/>
                    </a:ext>
                  </a:extLst>
                </a:gridCol>
                <a:gridCol w="154286">
                  <a:extLst>
                    <a:ext uri="{9D8B030D-6E8A-4147-A177-3AD203B41FA5}">
                      <a16:colId xmlns:a16="http://schemas.microsoft.com/office/drawing/2014/main" val="3146015335"/>
                    </a:ext>
                  </a:extLst>
                </a:gridCol>
                <a:gridCol w="154286">
                  <a:extLst>
                    <a:ext uri="{9D8B030D-6E8A-4147-A177-3AD203B41FA5}">
                      <a16:colId xmlns:a16="http://schemas.microsoft.com/office/drawing/2014/main" val="2126965722"/>
                    </a:ext>
                  </a:extLst>
                </a:gridCol>
                <a:gridCol w="154286">
                  <a:extLst>
                    <a:ext uri="{9D8B030D-6E8A-4147-A177-3AD203B41FA5}">
                      <a16:colId xmlns:a16="http://schemas.microsoft.com/office/drawing/2014/main" val="2669136215"/>
                    </a:ext>
                  </a:extLst>
                </a:gridCol>
                <a:gridCol w="154286">
                  <a:extLst>
                    <a:ext uri="{9D8B030D-6E8A-4147-A177-3AD203B41FA5}">
                      <a16:colId xmlns:a16="http://schemas.microsoft.com/office/drawing/2014/main" val="3647131408"/>
                    </a:ext>
                  </a:extLst>
                </a:gridCol>
                <a:gridCol w="154286">
                  <a:extLst>
                    <a:ext uri="{9D8B030D-6E8A-4147-A177-3AD203B41FA5}">
                      <a16:colId xmlns:a16="http://schemas.microsoft.com/office/drawing/2014/main" val="141552620"/>
                    </a:ext>
                  </a:extLst>
                </a:gridCol>
                <a:gridCol w="154286">
                  <a:extLst>
                    <a:ext uri="{9D8B030D-6E8A-4147-A177-3AD203B41FA5}">
                      <a16:colId xmlns:a16="http://schemas.microsoft.com/office/drawing/2014/main" val="3260762399"/>
                    </a:ext>
                  </a:extLst>
                </a:gridCol>
                <a:gridCol w="154286">
                  <a:extLst>
                    <a:ext uri="{9D8B030D-6E8A-4147-A177-3AD203B41FA5}">
                      <a16:colId xmlns:a16="http://schemas.microsoft.com/office/drawing/2014/main" val="2726284612"/>
                    </a:ext>
                  </a:extLst>
                </a:gridCol>
                <a:gridCol w="154286">
                  <a:extLst>
                    <a:ext uri="{9D8B030D-6E8A-4147-A177-3AD203B41FA5}">
                      <a16:colId xmlns:a16="http://schemas.microsoft.com/office/drawing/2014/main" val="2599857253"/>
                    </a:ext>
                  </a:extLst>
                </a:gridCol>
                <a:gridCol w="154286">
                  <a:extLst>
                    <a:ext uri="{9D8B030D-6E8A-4147-A177-3AD203B41FA5}">
                      <a16:colId xmlns:a16="http://schemas.microsoft.com/office/drawing/2014/main" val="1192897036"/>
                    </a:ext>
                  </a:extLst>
                </a:gridCol>
                <a:gridCol w="154286">
                  <a:extLst>
                    <a:ext uri="{9D8B030D-6E8A-4147-A177-3AD203B41FA5}">
                      <a16:colId xmlns:a16="http://schemas.microsoft.com/office/drawing/2014/main" val="3599808452"/>
                    </a:ext>
                  </a:extLst>
                </a:gridCol>
                <a:gridCol w="154286">
                  <a:extLst>
                    <a:ext uri="{9D8B030D-6E8A-4147-A177-3AD203B41FA5}">
                      <a16:colId xmlns:a16="http://schemas.microsoft.com/office/drawing/2014/main" val="1939417053"/>
                    </a:ext>
                  </a:extLst>
                </a:gridCol>
              </a:tblGrid>
              <a:tr h="170970"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ø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de-DE" sz="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DL</a:t>
                      </a:r>
                      <a:endParaRPr lang="de-DE" sz="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LDL</a:t>
                      </a:r>
                      <a:endParaRPr lang="de-DE" sz="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ø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de-DE" sz="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DL</a:t>
                      </a:r>
                      <a:endParaRPr lang="de-DE" sz="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LDL</a:t>
                      </a:r>
                      <a:endParaRPr lang="de-DE" sz="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ø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de-DE" sz="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DL</a:t>
                      </a:r>
                      <a:endParaRPr lang="de-DE" sz="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LDL</a:t>
                      </a:r>
                      <a:endParaRPr lang="de-DE" sz="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9275720"/>
                  </a:ext>
                </a:extLst>
              </a:tr>
              <a:tr h="170970"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9840941"/>
                  </a:ext>
                </a:extLst>
              </a:tr>
              <a:tr h="170970"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32039"/>
                  </a:ext>
                </a:extLst>
              </a:tr>
              <a:tr h="170970"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0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0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de-DE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00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de-DE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00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de-DE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00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  <a:endParaRPr kumimoji="0" lang="de-DE" sz="5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  <a:endParaRPr kumimoji="0" lang="de-DE" sz="5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  <a:endParaRPr kumimoji="0" lang="de-DE" sz="5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  <a:endParaRPr kumimoji="0" lang="de-DE" sz="5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0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000</a:t>
                      </a:r>
                      <a:endParaRPr kumimoji="0" lang="de-DE" sz="5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000</a:t>
                      </a:r>
                      <a:endParaRPr kumimoji="0" lang="de-DE" sz="5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000</a:t>
                      </a:r>
                      <a:endParaRPr kumimoji="0" lang="de-DE" sz="5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7767824"/>
                  </a:ext>
                </a:extLst>
              </a:tr>
            </a:tbl>
          </a:graphicData>
        </a:graphic>
      </p:graphicFrame>
      <p:pic>
        <p:nvPicPr>
          <p:cNvPr id="30" name="Grafik 2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88" t="31115" r="20243" b="64083"/>
          <a:stretch/>
        </p:blipFill>
        <p:spPr>
          <a:xfrm>
            <a:off x="2963463" y="2411780"/>
            <a:ext cx="2160000" cy="15513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Grafik 3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91" t="23359" r="18039" b="71285"/>
          <a:stretch/>
        </p:blipFill>
        <p:spPr>
          <a:xfrm>
            <a:off x="2963463" y="2570175"/>
            <a:ext cx="2160000" cy="1730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Grafik 3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62" t="37025" r="13769" b="58542"/>
          <a:stretch/>
        </p:blipFill>
        <p:spPr>
          <a:xfrm>
            <a:off x="2963463" y="2747500"/>
            <a:ext cx="2160000" cy="1432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Grafik 3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26" t="37580" r="19005" b="58357"/>
          <a:stretch/>
        </p:blipFill>
        <p:spPr>
          <a:xfrm>
            <a:off x="2963463" y="2893290"/>
            <a:ext cx="2160000" cy="1312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Grafik 3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03" t="44228" r="17626" b="50601"/>
          <a:stretch/>
        </p:blipFill>
        <p:spPr>
          <a:xfrm>
            <a:off x="2963463" y="3028576"/>
            <a:ext cx="2160000" cy="1670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Grafik 34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31" t="39057" r="16801" b="56695"/>
          <a:stretch/>
        </p:blipFill>
        <p:spPr>
          <a:xfrm>
            <a:off x="2963463" y="3188279"/>
            <a:ext cx="2160000" cy="13723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6" name="Textfeld 35"/>
          <p:cNvSpPr txBox="1"/>
          <p:nvPr/>
        </p:nvSpPr>
        <p:spPr>
          <a:xfrm>
            <a:off x="5075612" y="1609061"/>
            <a:ext cx="3946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ADD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3466664" y="1350248"/>
            <a:ext cx="15160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ADD </a:t>
            </a:r>
            <a:r>
              <a:rPr lang="de-DE" sz="7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RIPK3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2576090" y="125220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2751547" y="319129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16076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77" t="29638" r="19278" b="66484"/>
          <a:stretch/>
        </p:blipFill>
        <p:spPr>
          <a:xfrm>
            <a:off x="689186" y="201802"/>
            <a:ext cx="2160000" cy="12536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5" name="Gerade Verbindung mit Pfeil 4"/>
          <p:cNvCxnSpPr/>
          <p:nvPr/>
        </p:nvCxnSpPr>
        <p:spPr>
          <a:xfrm flipH="1">
            <a:off x="7965400" y="262171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feld 5"/>
          <p:cNvSpPr txBox="1"/>
          <p:nvPr/>
        </p:nvSpPr>
        <p:spPr>
          <a:xfrm>
            <a:off x="8039075" y="162424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5572790" y="21036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Gerade Verbindung mit Pfeil 21"/>
          <p:cNvCxnSpPr/>
          <p:nvPr/>
        </p:nvCxnSpPr>
        <p:spPr>
          <a:xfrm flipH="1">
            <a:off x="2876666" y="240967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feld 22"/>
          <p:cNvSpPr txBox="1"/>
          <p:nvPr/>
        </p:nvSpPr>
        <p:spPr>
          <a:xfrm>
            <a:off x="2950341" y="137319"/>
            <a:ext cx="4507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484056" y="17212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Grafik 2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88" t="31115" r="20243" b="64083"/>
          <a:stretch/>
        </p:blipFill>
        <p:spPr>
          <a:xfrm>
            <a:off x="5777920" y="201658"/>
            <a:ext cx="2160000" cy="15513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Grafik 3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93" t="10800" r="16937" b="25482"/>
          <a:stretch/>
        </p:blipFill>
        <p:spPr>
          <a:xfrm>
            <a:off x="484056" y="618005"/>
            <a:ext cx="3188874" cy="2650991"/>
          </a:xfrm>
          <a:prstGeom prst="rect">
            <a:avLst/>
          </a:prstGeom>
        </p:spPr>
      </p:pic>
      <p:pic>
        <p:nvPicPr>
          <p:cNvPr id="33" name="Grafik 3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41" r="18366" b="25838"/>
          <a:stretch/>
        </p:blipFill>
        <p:spPr>
          <a:xfrm>
            <a:off x="184415" y="3646033"/>
            <a:ext cx="3865069" cy="3085531"/>
          </a:xfrm>
          <a:prstGeom prst="rect">
            <a:avLst/>
          </a:prstGeom>
        </p:spPr>
      </p:pic>
      <p:pic>
        <p:nvPicPr>
          <p:cNvPr id="34" name="Grafik 3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41" t="8245" r="18178" b="26005"/>
          <a:stretch/>
        </p:blipFill>
        <p:spPr>
          <a:xfrm>
            <a:off x="5282693" y="702562"/>
            <a:ext cx="3150453" cy="2735516"/>
          </a:xfrm>
          <a:prstGeom prst="rect">
            <a:avLst/>
          </a:prstGeom>
        </p:spPr>
      </p:pic>
      <p:pic>
        <p:nvPicPr>
          <p:cNvPr id="35" name="Grafik 3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764" b="27914"/>
          <a:stretch/>
        </p:blipFill>
        <p:spPr>
          <a:xfrm>
            <a:off x="4403237" y="3689222"/>
            <a:ext cx="4586985" cy="2999152"/>
          </a:xfrm>
          <a:prstGeom prst="rect">
            <a:avLst/>
          </a:prstGeom>
        </p:spPr>
      </p:pic>
      <p:sp>
        <p:nvSpPr>
          <p:cNvPr id="36" name="Rechteck 35"/>
          <p:cNvSpPr/>
          <p:nvPr/>
        </p:nvSpPr>
        <p:spPr>
          <a:xfrm>
            <a:off x="292127" y="3810911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292127" y="459802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292127" y="468544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292127" y="477680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292127" y="487746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292127" y="506263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292127" y="527504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292127" y="563925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292127" y="58461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292127" y="610987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292127" y="635760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292127" y="443799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982612" y="4365703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9" name="Rechteck 48"/>
          <p:cNvSpPr/>
          <p:nvPr/>
        </p:nvSpPr>
        <p:spPr>
          <a:xfrm>
            <a:off x="689186" y="1353121"/>
            <a:ext cx="2832645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0" name="Rechteck 49"/>
          <p:cNvSpPr/>
          <p:nvPr/>
        </p:nvSpPr>
        <p:spPr>
          <a:xfrm>
            <a:off x="5129512" y="3810911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5129512" y="459802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Rechteck 51"/>
          <p:cNvSpPr/>
          <p:nvPr/>
        </p:nvSpPr>
        <p:spPr>
          <a:xfrm>
            <a:off x="5129512" y="468544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3" name="Rechteck 52"/>
          <p:cNvSpPr/>
          <p:nvPr/>
        </p:nvSpPr>
        <p:spPr>
          <a:xfrm>
            <a:off x="5129512" y="477680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4" name="Rechteck 53"/>
          <p:cNvSpPr/>
          <p:nvPr/>
        </p:nvSpPr>
        <p:spPr>
          <a:xfrm>
            <a:off x="5129512" y="487746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5" name="Rechteck 54"/>
          <p:cNvSpPr/>
          <p:nvPr/>
        </p:nvSpPr>
        <p:spPr>
          <a:xfrm>
            <a:off x="5129512" y="506263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6" name="Rechteck 55"/>
          <p:cNvSpPr/>
          <p:nvPr/>
        </p:nvSpPr>
        <p:spPr>
          <a:xfrm>
            <a:off x="5129512" y="527504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7" name="Rechteck 56"/>
          <p:cNvSpPr/>
          <p:nvPr/>
        </p:nvSpPr>
        <p:spPr>
          <a:xfrm>
            <a:off x="5129512" y="563925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8" name="Rechteck 57"/>
          <p:cNvSpPr/>
          <p:nvPr/>
        </p:nvSpPr>
        <p:spPr>
          <a:xfrm>
            <a:off x="5129512" y="58461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9" name="Rechteck 58"/>
          <p:cNvSpPr/>
          <p:nvPr/>
        </p:nvSpPr>
        <p:spPr>
          <a:xfrm>
            <a:off x="5129512" y="610987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0" name="Rechteck 59"/>
          <p:cNvSpPr/>
          <p:nvPr/>
        </p:nvSpPr>
        <p:spPr>
          <a:xfrm>
            <a:off x="5129512" y="635760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1" name="Rechteck 60"/>
          <p:cNvSpPr/>
          <p:nvPr/>
        </p:nvSpPr>
        <p:spPr>
          <a:xfrm>
            <a:off x="5129512" y="443799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2" name="Textfeld 61"/>
          <p:cNvSpPr txBox="1"/>
          <p:nvPr/>
        </p:nvSpPr>
        <p:spPr>
          <a:xfrm>
            <a:off x="5819997" y="4365703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63" name="Rechteck 62"/>
          <p:cNvSpPr/>
          <p:nvPr/>
        </p:nvSpPr>
        <p:spPr>
          <a:xfrm>
            <a:off x="5511864" y="1655511"/>
            <a:ext cx="2832645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98070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Gerade Verbindung mit Pfeil 1"/>
          <p:cNvCxnSpPr/>
          <p:nvPr/>
        </p:nvCxnSpPr>
        <p:spPr>
          <a:xfrm flipH="1">
            <a:off x="2785813" y="224335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feld 2"/>
          <p:cNvSpPr txBox="1"/>
          <p:nvPr/>
        </p:nvSpPr>
        <p:spPr>
          <a:xfrm>
            <a:off x="2859488" y="131868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393203" y="18535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Gerade Verbindung mit Pfeil 4"/>
          <p:cNvCxnSpPr/>
          <p:nvPr/>
        </p:nvCxnSpPr>
        <p:spPr>
          <a:xfrm flipH="1">
            <a:off x="7760270" y="221089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feld 5"/>
          <p:cNvSpPr txBox="1"/>
          <p:nvPr/>
        </p:nvSpPr>
        <p:spPr>
          <a:xfrm>
            <a:off x="7833945" y="131487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5367660" y="17850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91" t="23359" r="18039" b="71285"/>
          <a:stretch/>
        </p:blipFill>
        <p:spPr>
          <a:xfrm>
            <a:off x="598333" y="170852"/>
            <a:ext cx="2160000" cy="1730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Grafik 1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62" t="37025" r="13769" b="58542"/>
          <a:stretch/>
        </p:blipFill>
        <p:spPr>
          <a:xfrm>
            <a:off x="5572790" y="189864"/>
            <a:ext cx="2160000" cy="1432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Grafik 2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96" t="4336" r="15422" b="32131"/>
          <a:stretch/>
        </p:blipFill>
        <p:spPr>
          <a:xfrm>
            <a:off x="870756" y="708819"/>
            <a:ext cx="3150453" cy="2643307"/>
          </a:xfrm>
          <a:prstGeom prst="rect">
            <a:avLst/>
          </a:prstGeom>
        </p:spPr>
      </p:pic>
      <p:pic>
        <p:nvPicPr>
          <p:cNvPr id="23" name="Grafik 2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36" r="15422" b="31023"/>
          <a:stretch/>
        </p:blipFill>
        <p:spPr>
          <a:xfrm>
            <a:off x="528817" y="3717054"/>
            <a:ext cx="3834332" cy="2869794"/>
          </a:xfrm>
          <a:prstGeom prst="rect">
            <a:avLst/>
          </a:prstGeom>
        </p:spPr>
      </p:pic>
      <p:pic>
        <p:nvPicPr>
          <p:cNvPr id="24" name="Grafik 2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05" t="13016" r="11703" b="21604"/>
          <a:stretch/>
        </p:blipFill>
        <p:spPr>
          <a:xfrm>
            <a:off x="5217459" y="619056"/>
            <a:ext cx="3112033" cy="2720148"/>
          </a:xfrm>
          <a:prstGeom prst="rect">
            <a:avLst/>
          </a:prstGeom>
        </p:spPr>
      </p:pic>
      <p:pic>
        <p:nvPicPr>
          <p:cNvPr id="25" name="Grafik 2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47" r="12667" b="22850"/>
          <a:stretch/>
        </p:blipFill>
        <p:spPr>
          <a:xfrm>
            <a:off x="5025358" y="3547045"/>
            <a:ext cx="4026434" cy="3209813"/>
          </a:xfrm>
          <a:prstGeom prst="rect">
            <a:avLst/>
          </a:prstGeom>
        </p:spPr>
      </p:pic>
      <p:sp>
        <p:nvSpPr>
          <p:cNvPr id="26" name="Rechteck 25"/>
          <p:cNvSpPr/>
          <p:nvPr/>
        </p:nvSpPr>
        <p:spPr>
          <a:xfrm>
            <a:off x="528817" y="3663565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528817" y="445067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Rechteck 27"/>
          <p:cNvSpPr/>
          <p:nvPr/>
        </p:nvSpPr>
        <p:spPr>
          <a:xfrm>
            <a:off x="528817" y="453809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528817" y="462946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528817" y="473012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528817" y="491529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528817" y="51276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528817" y="549190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528817" y="569875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528817" y="59625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528817" y="621026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528817" y="429064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1219302" y="4218357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39" name="Rechteck 38"/>
          <p:cNvSpPr/>
          <p:nvPr/>
        </p:nvSpPr>
        <p:spPr>
          <a:xfrm>
            <a:off x="1029659" y="1482497"/>
            <a:ext cx="2832645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0" name="Rechteck 39"/>
          <p:cNvSpPr/>
          <p:nvPr/>
        </p:nvSpPr>
        <p:spPr>
          <a:xfrm>
            <a:off x="5281527" y="3866699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5281527" y="465381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5281527" y="474122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5281527" y="483259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5281527" y="493325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5281527" y="511842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5281527" y="53308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5281527" y="569504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5281527" y="590189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5281527" y="616566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5281527" y="641339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5281527" y="449377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5972012" y="4421491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3" name="Rechteck 52"/>
          <p:cNvSpPr/>
          <p:nvPr/>
        </p:nvSpPr>
        <p:spPr>
          <a:xfrm>
            <a:off x="5367660" y="1588875"/>
            <a:ext cx="2832645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17243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Gerade Verbindung mit Pfeil 1"/>
          <p:cNvCxnSpPr/>
          <p:nvPr/>
        </p:nvCxnSpPr>
        <p:spPr>
          <a:xfrm flipH="1">
            <a:off x="2689097" y="199767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feld 2"/>
          <p:cNvSpPr txBox="1"/>
          <p:nvPr/>
        </p:nvSpPr>
        <p:spPr>
          <a:xfrm>
            <a:off x="2762772" y="106882"/>
            <a:ext cx="3866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296487" y="14421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Gerade Verbindung mit Pfeil 4"/>
          <p:cNvCxnSpPr/>
          <p:nvPr/>
        </p:nvCxnSpPr>
        <p:spPr>
          <a:xfrm flipH="1">
            <a:off x="7531953" y="208012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feld 5"/>
          <p:cNvSpPr txBox="1"/>
          <p:nvPr/>
        </p:nvSpPr>
        <p:spPr>
          <a:xfrm>
            <a:off x="7605628" y="113113"/>
            <a:ext cx="3946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ADD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5139343" y="14411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26" t="37580" r="19005" b="58357"/>
          <a:stretch/>
        </p:blipFill>
        <p:spPr>
          <a:xfrm>
            <a:off x="501617" y="165720"/>
            <a:ext cx="2160000" cy="1312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Grafik 1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03" t="44228" r="17626" b="50601"/>
          <a:stretch/>
        </p:blipFill>
        <p:spPr>
          <a:xfrm>
            <a:off x="5344473" y="124476"/>
            <a:ext cx="2160000" cy="1670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Grafik 1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06" t="10984" r="17626" b="22343"/>
          <a:stretch/>
        </p:blipFill>
        <p:spPr>
          <a:xfrm>
            <a:off x="296487" y="421768"/>
            <a:ext cx="3127402" cy="2773936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81" r="17075" b="21604"/>
          <a:stretch/>
        </p:blipFill>
        <p:spPr>
          <a:xfrm>
            <a:off x="296487" y="3492586"/>
            <a:ext cx="3895805" cy="3261680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6524" b="25482"/>
          <a:stretch/>
        </p:blipFill>
        <p:spPr>
          <a:xfrm>
            <a:off x="4326495" y="3653951"/>
            <a:ext cx="4656140" cy="3100315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67" t="8214" r="15560" b="28622"/>
          <a:stretch/>
        </p:blipFill>
        <p:spPr>
          <a:xfrm>
            <a:off x="5139343" y="386447"/>
            <a:ext cx="2904564" cy="2627940"/>
          </a:xfrm>
          <a:prstGeom prst="rect">
            <a:avLst/>
          </a:prstGeom>
        </p:spPr>
      </p:pic>
      <p:sp>
        <p:nvSpPr>
          <p:cNvPr id="18" name="Rechteck 17"/>
          <p:cNvSpPr/>
          <p:nvPr/>
        </p:nvSpPr>
        <p:spPr>
          <a:xfrm>
            <a:off x="414816" y="3835268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414816" y="462238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0" name="Rechteck 19"/>
          <p:cNvSpPr/>
          <p:nvPr/>
        </p:nvSpPr>
        <p:spPr>
          <a:xfrm>
            <a:off x="414816" y="470979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1" name="Rechteck 20"/>
          <p:cNvSpPr/>
          <p:nvPr/>
        </p:nvSpPr>
        <p:spPr>
          <a:xfrm>
            <a:off x="414816" y="480116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414816" y="490182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414816" y="50869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414816" y="529939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414816" y="566361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6" name="Rechteck 25"/>
          <p:cNvSpPr/>
          <p:nvPr/>
        </p:nvSpPr>
        <p:spPr>
          <a:xfrm>
            <a:off x="414816" y="587046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414816" y="613423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Rechteck 27"/>
          <p:cNvSpPr/>
          <p:nvPr/>
        </p:nvSpPr>
        <p:spPr>
          <a:xfrm>
            <a:off x="414816" y="638196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414816" y="446234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1105301" y="4390060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31" name="Rechteck 30"/>
          <p:cNvSpPr/>
          <p:nvPr/>
        </p:nvSpPr>
        <p:spPr>
          <a:xfrm>
            <a:off x="567715" y="1480961"/>
            <a:ext cx="2832645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2" name="Rechteck 31"/>
          <p:cNvSpPr/>
          <p:nvPr/>
        </p:nvSpPr>
        <p:spPr>
          <a:xfrm>
            <a:off x="5232321" y="3835268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5232321" y="462238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5232321" y="470979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5232321" y="480116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5232321" y="490182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5232321" y="50869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5232321" y="529939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5232321" y="566361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5232321" y="587046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5232321" y="613423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5232321" y="638196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5232321" y="446234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5922806" y="4390060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5" name="Rechteck 44"/>
          <p:cNvSpPr/>
          <p:nvPr/>
        </p:nvSpPr>
        <p:spPr>
          <a:xfrm>
            <a:off x="5139343" y="1865839"/>
            <a:ext cx="2832645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73490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Gerade Verbindung mit Pfeil 1"/>
          <p:cNvCxnSpPr/>
          <p:nvPr/>
        </p:nvCxnSpPr>
        <p:spPr>
          <a:xfrm flipH="1">
            <a:off x="2922573" y="205370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feld 2"/>
          <p:cNvSpPr txBox="1"/>
          <p:nvPr/>
        </p:nvSpPr>
        <p:spPr>
          <a:xfrm>
            <a:off x="2996248" y="110553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31" t="39057" r="16801" b="56695"/>
          <a:stretch/>
        </p:blipFill>
        <p:spPr>
          <a:xfrm>
            <a:off x="735093" y="160769"/>
            <a:ext cx="2160000" cy="13723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feld 4"/>
          <p:cNvSpPr txBox="1"/>
          <p:nvPr/>
        </p:nvSpPr>
        <p:spPr>
          <a:xfrm>
            <a:off x="523177" y="16378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70" t="9506" r="14320" b="21236"/>
          <a:stretch/>
        </p:blipFill>
        <p:spPr>
          <a:xfrm>
            <a:off x="794405" y="443266"/>
            <a:ext cx="3258031" cy="2881512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009" b="23266"/>
          <a:stretch/>
        </p:blipFill>
        <p:spPr>
          <a:xfrm>
            <a:off x="376902" y="3569425"/>
            <a:ext cx="4740665" cy="3192524"/>
          </a:xfrm>
          <a:prstGeom prst="rect">
            <a:avLst/>
          </a:prstGeom>
        </p:spPr>
      </p:pic>
      <p:sp>
        <p:nvSpPr>
          <p:cNvPr id="8" name="Rechteck 7"/>
          <p:cNvSpPr/>
          <p:nvPr/>
        </p:nvSpPr>
        <p:spPr>
          <a:xfrm>
            <a:off x="1321788" y="3861434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9" name="Rechteck 8"/>
          <p:cNvSpPr/>
          <p:nvPr/>
        </p:nvSpPr>
        <p:spPr>
          <a:xfrm>
            <a:off x="1321788" y="464854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" name="Rechteck 9"/>
          <p:cNvSpPr/>
          <p:nvPr/>
        </p:nvSpPr>
        <p:spPr>
          <a:xfrm>
            <a:off x="1321788" y="473596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1" name="Rechteck 10"/>
          <p:cNvSpPr/>
          <p:nvPr/>
        </p:nvSpPr>
        <p:spPr>
          <a:xfrm>
            <a:off x="1321788" y="482733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2" name="Rechteck 11"/>
          <p:cNvSpPr/>
          <p:nvPr/>
        </p:nvSpPr>
        <p:spPr>
          <a:xfrm>
            <a:off x="1321788" y="492799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3" name="Rechteck 12"/>
          <p:cNvSpPr/>
          <p:nvPr/>
        </p:nvSpPr>
        <p:spPr>
          <a:xfrm>
            <a:off x="1321788" y="511316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4" name="Rechteck 13"/>
          <p:cNvSpPr/>
          <p:nvPr/>
        </p:nvSpPr>
        <p:spPr>
          <a:xfrm>
            <a:off x="1321788" y="532556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5" name="Rechteck 14"/>
          <p:cNvSpPr/>
          <p:nvPr/>
        </p:nvSpPr>
        <p:spPr>
          <a:xfrm>
            <a:off x="1321788" y="568977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6" name="Rechteck 15"/>
          <p:cNvSpPr/>
          <p:nvPr/>
        </p:nvSpPr>
        <p:spPr>
          <a:xfrm>
            <a:off x="1321788" y="58966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7" name="Rechteck 16"/>
          <p:cNvSpPr/>
          <p:nvPr/>
        </p:nvSpPr>
        <p:spPr>
          <a:xfrm>
            <a:off x="1321788" y="616039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8" name="Rechteck 17"/>
          <p:cNvSpPr/>
          <p:nvPr/>
        </p:nvSpPr>
        <p:spPr>
          <a:xfrm>
            <a:off x="1321788" y="640813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1321788" y="448851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2012273" y="4416226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21" name="Rechteck 20"/>
          <p:cNvSpPr/>
          <p:nvPr/>
        </p:nvSpPr>
        <p:spPr>
          <a:xfrm>
            <a:off x="1093895" y="1664566"/>
            <a:ext cx="2832645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51025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0</Words>
  <Application>Microsoft Office PowerPoint</Application>
  <PresentationFormat>Bildschirmpräsentation (4:3)</PresentationFormat>
  <Paragraphs>182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önig, Corinna</dc:creator>
  <cp:lastModifiedBy>König, Corinna</cp:lastModifiedBy>
  <cp:revision>3</cp:revision>
  <dcterms:created xsi:type="dcterms:W3CDTF">2024-10-21T12:55:10Z</dcterms:created>
  <dcterms:modified xsi:type="dcterms:W3CDTF">2024-10-21T13:13:52Z</dcterms:modified>
</cp:coreProperties>
</file>